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5" y="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A444EB-8AFC-43F2-9798-007F99B79B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316A822-AA6A-4015-B37B-43C4A59CF95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A239CB-81C7-4C4E-9E45-DA6ACAA3FE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8BA66-A5B9-4924-8E30-890DBEFF30C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7B4F1E-71C2-4B7D-A70F-8DF8CF9CBF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6BEDF3-1E9C-4A72-8DBE-904C2DD362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29B7E-6A70-4232-B52A-957C063D7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529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20D299-1889-47A3-89A6-66EAF12FAC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F78919-74BA-4851-97C7-6DEBD5D00A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99F095-595F-4A58-8B41-5D27CFAF46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8BA66-A5B9-4924-8E30-890DBEFF30C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314182-6DBB-47CE-8717-6F9167AFE9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DA6C55-AFF6-4907-B6EA-A0A7B286E6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29B7E-6A70-4232-B52A-957C063D7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443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AB17F7A-9C37-484E-9948-54C456F8DF5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655E07D-9174-441C-80DE-3E7644F93A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52CD9A-05BC-4D9F-A558-01B1E9477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8BA66-A5B9-4924-8E30-890DBEFF30C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E51E0D-27B9-4705-BEB7-34865B616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CDB3D7-241E-45FE-914A-8A309592A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29B7E-6A70-4232-B52A-957C063D7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6134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F3CC35-7231-42E6-9D20-C7A7DEA23A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496BB3-0DAE-4E00-ADF8-B8189EDF7D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C00F4D-4B7A-4A64-9313-664399D1C6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8BA66-A5B9-4924-8E30-890DBEFF30C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DF6162-2CAB-4695-9FD8-E63DE46B74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DBC3E7-C8EF-4DC0-BD2C-39B36AE6F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29B7E-6A70-4232-B52A-957C063D7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097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B62A58-7878-4C35-A379-B3C2EC0ECB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0D1C81-A759-4BDA-BF02-B0D181BD4B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C6AE8B-6F77-47AA-9B9F-B70795A2DE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8BA66-A5B9-4924-8E30-890DBEFF30C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BA79CB-75F5-4A92-BF06-59B167565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DAC3A4-B236-4339-BE88-2C50BF9A2F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29B7E-6A70-4232-B52A-957C063D7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5864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B36FF0-B556-4CC1-8697-320481C219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242C3F-27D2-4C88-9DFD-1B16A401F9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6E253B-858F-466C-993B-CCCEA721D1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6741F2-0B5C-409A-8D17-336DAB3270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8BA66-A5B9-4924-8E30-890DBEFF30C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186BBA-EA60-434D-A9EE-B3CB61DD9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D02953-7AC0-403E-A1D6-02386BEA10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29B7E-6A70-4232-B52A-957C063D7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626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4CE4DB-DB77-4F84-B17D-6C618AC110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CE9CCF-5EDA-4ADB-BB80-F09EE21C83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8363663-C6C2-4077-9644-5C472373BE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12F9A9C-39C7-45C4-9D78-719F6B29BA1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95781DB-C4B3-4050-965B-267B42B403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A9B03C3-E3E7-4CBD-B6EB-000C9A9FD8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8BA66-A5B9-4924-8E30-890DBEFF30C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0597B19-D824-48F3-B550-5499C3214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E1DF89F-1B2A-467B-9C12-08C9563072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29B7E-6A70-4232-B52A-957C063D7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5861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691884-A0A8-49D0-9F15-522A2B346C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BED916F-CA6B-4559-8FFE-008AF5ECA4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8BA66-A5B9-4924-8E30-890DBEFF30C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E12D87E-A754-40E5-BD95-66D224644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67904BA-6141-4B88-A4B7-20D52AD03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29B7E-6A70-4232-B52A-957C063D7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3003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ED56BAC-513F-4F0B-9915-FE676439C6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8BA66-A5B9-4924-8E30-890DBEFF30C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7AFEEA-0B27-424A-9104-C5AD1EC52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AD3265-FBAF-4177-8B26-AA8F48CF03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29B7E-6A70-4232-B52A-957C063D7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2606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6C29F1-A440-4F2E-8805-F5D241BCBD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EBE19F-C852-49C0-BD76-76AD7A6D10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51748B-3903-4F71-8F1B-36CD2CBF42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45EB1B-CCBC-4F48-AC44-07B2DC0A77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8BA66-A5B9-4924-8E30-890DBEFF30C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44142F-49AC-4FEF-B59E-EB37BDC90F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BC5C84-2E15-4CF0-B8D0-A3D284767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29B7E-6A70-4232-B52A-957C063D7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49800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E2705C-047D-4C02-816B-CC0D978982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A5A138C-0E0F-4D0A-B3BF-75E74115FD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FF3A8F3-6C84-4509-B34D-2AE5876540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FA381E-41AF-48B4-973A-1769862E13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8BA66-A5B9-4924-8E30-890DBEFF30C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631337-6F43-438A-B065-31A3BEF0C7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318AE9-C5E8-4071-931D-6889C25EA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29B7E-6A70-4232-B52A-957C063D7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687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7956C15-3A26-4A03-AA87-F736A8048F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0C249F-6DDA-4F96-8E45-5883F007BE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C43391-6D39-4028-9BAF-C83277DD65A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F8BA66-A5B9-4924-8E30-890DBEFF30C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40A52B-5838-417B-ACD8-27EDD545B2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5E8525-11CF-4469-9CCA-D495059A2B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B29B7E-6A70-4232-B52A-957C063D7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7498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1828800" y="1064895"/>
          <a:ext cx="8763000" cy="54226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90600">
                  <a:extLst>
                    <a:ext uri="{9D8B030D-6E8A-4147-A177-3AD203B41FA5}">
                      <a16:colId xmlns:a16="http://schemas.microsoft.com/office/drawing/2014/main" val="3020974570"/>
                    </a:ext>
                  </a:extLst>
                </a:gridCol>
                <a:gridCol w="1917700">
                  <a:extLst>
                    <a:ext uri="{9D8B030D-6E8A-4147-A177-3AD203B41FA5}">
                      <a16:colId xmlns:a16="http://schemas.microsoft.com/office/drawing/2014/main" val="3078550569"/>
                    </a:ext>
                  </a:extLst>
                </a:gridCol>
                <a:gridCol w="1955800">
                  <a:extLst>
                    <a:ext uri="{9D8B030D-6E8A-4147-A177-3AD203B41FA5}">
                      <a16:colId xmlns:a16="http://schemas.microsoft.com/office/drawing/2014/main" val="205561854"/>
                    </a:ext>
                  </a:extLst>
                </a:gridCol>
                <a:gridCol w="1968500">
                  <a:extLst>
                    <a:ext uri="{9D8B030D-6E8A-4147-A177-3AD203B41FA5}">
                      <a16:colId xmlns:a16="http://schemas.microsoft.com/office/drawing/2014/main" val="214209919"/>
                    </a:ext>
                  </a:extLst>
                </a:gridCol>
                <a:gridCol w="1930400">
                  <a:extLst>
                    <a:ext uri="{9D8B030D-6E8A-4147-A177-3AD203B41FA5}">
                      <a16:colId xmlns:a16="http://schemas.microsoft.com/office/drawing/2014/main" val="1305851498"/>
                    </a:ext>
                  </a:extLst>
                </a:gridCol>
              </a:tblGrid>
              <a:tr h="274320">
                <a:tc>
                  <a:txBody>
                    <a:bodyPr/>
                    <a:lstStyle/>
                    <a:p>
                      <a:pPr algn="ctr"/>
                      <a:endParaRPr lang="en-US" sz="1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0" dirty="0">
                          <a:latin typeface="+mn-lt"/>
                          <a:cs typeface="Arial" panose="020B0604020202020204" pitchFamily="34" charset="0"/>
                        </a:rPr>
                        <a:t>POD4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0" dirty="0"/>
                        <a:t>POD18</a:t>
                      </a:r>
                      <a:endParaRPr lang="en-US" sz="1000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0" dirty="0"/>
                        <a:t>POD35</a:t>
                      </a:r>
                      <a:endParaRPr lang="en-US" sz="1000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0" dirty="0"/>
                        <a:t>POD56</a:t>
                      </a:r>
                      <a:endParaRPr lang="en-US" sz="1000" i="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63727804"/>
                  </a:ext>
                </a:extLst>
              </a:tr>
              <a:tr h="2229538">
                <a:tc>
                  <a:txBody>
                    <a:bodyPr/>
                    <a:lstStyle/>
                    <a:p>
                      <a:pPr algn="ctr"/>
                      <a:r>
                        <a:rPr lang="en-US" sz="1000" i="0" dirty="0"/>
                        <a:t>Infected </a:t>
                      </a:r>
                    </a:p>
                    <a:p>
                      <a:pPr algn="ctr"/>
                      <a:r>
                        <a:rPr lang="en-US" sz="1000" i="0" dirty="0"/>
                        <a:t>1e2</a:t>
                      </a:r>
                      <a:endParaRPr lang="en-US" sz="1000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88125496"/>
                  </a:ext>
                </a:extLst>
              </a:tr>
              <a:tr h="2363177">
                <a:tc>
                  <a:txBody>
                    <a:bodyPr/>
                    <a:lstStyle/>
                    <a:p>
                      <a:pPr algn="ctr"/>
                      <a:r>
                        <a:rPr lang="en-US" sz="1000" i="0" dirty="0"/>
                        <a:t>Sterile Control</a:t>
                      </a:r>
                      <a:endParaRPr lang="en-US" sz="1000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93384016"/>
                  </a:ext>
                </a:extLst>
              </a:tr>
              <a:tr h="555585">
                <a:tc gridSpan="5">
                  <a:txBody>
                    <a:bodyPr/>
                    <a:lstStyle/>
                    <a:p>
                      <a:pPr algn="l"/>
                      <a:r>
                        <a:rPr lang="en-US" sz="8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emental Figure 10. CD31 stain of capsule in cortical allograft specimens. CD31 stain, a marker of endothelial cell presence, brown. (</a:t>
                      </a:r>
                      <a:r>
                        <a:rPr lang="en-US" sz="800" b="0" i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r>
                        <a:rPr lang="en-US" sz="8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iv) CD31 staining of capsule at POD4, 18, 35, and 56 shows significant staining of CD31. (v-viii) CD31 staining of capsule at POD4, 18, 35, and 56 shows moderate staining of CD31. + = CD31 presence.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05373512"/>
                  </a:ext>
                </a:extLst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5959498" y="2797189"/>
            <a:ext cx="5279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200x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36" t="9575" r="34844" b="38543"/>
          <a:stretch/>
        </p:blipFill>
        <p:spPr>
          <a:xfrm>
            <a:off x="8901456" y="1401238"/>
            <a:ext cx="1580333" cy="210711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17" t="40466" r="39285" b="13190"/>
          <a:stretch/>
        </p:blipFill>
        <p:spPr>
          <a:xfrm>
            <a:off x="8912746" y="3628319"/>
            <a:ext cx="1574286" cy="2187764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597" t="27811" r="25851" b="18549"/>
          <a:stretch/>
        </p:blipFill>
        <p:spPr>
          <a:xfrm>
            <a:off x="4922630" y="1378209"/>
            <a:ext cx="1614876" cy="2153168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80" t="27669" r="44072" b="22331"/>
          <a:stretch/>
        </p:blipFill>
        <p:spPr>
          <a:xfrm>
            <a:off x="4950436" y="3633835"/>
            <a:ext cx="1609358" cy="2187765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505" t="16922" r="17556" b="16877"/>
          <a:stretch/>
        </p:blipFill>
        <p:spPr>
          <a:xfrm>
            <a:off x="6879934" y="1371575"/>
            <a:ext cx="1619852" cy="2159802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55" t="16289" r="21438" b="6516"/>
          <a:stretch/>
        </p:blipFill>
        <p:spPr>
          <a:xfrm>
            <a:off x="6869184" y="3628319"/>
            <a:ext cx="1640824" cy="2187765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2827334" y="3282519"/>
            <a:ext cx="2135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i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697772" y="3310878"/>
            <a:ext cx="2295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ii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6634619" y="3319825"/>
            <a:ext cx="2519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iii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661917" y="3316320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iv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827334" y="558513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v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664180" y="5585130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vi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625490" y="5585130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vii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8592915" y="5560576"/>
            <a:ext cx="8684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viii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B3F0B398-120C-4F30-B32B-C4848ED9456C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63005" t="37374"/>
          <a:stretch/>
        </p:blipFill>
        <p:spPr>
          <a:xfrm>
            <a:off x="3016498" y="1384193"/>
            <a:ext cx="1601804" cy="2126719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BBAE576F-E601-4BB0-BBAB-7A760FFD44D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67148" t="42824"/>
          <a:stretch/>
        </p:blipFill>
        <p:spPr>
          <a:xfrm>
            <a:off x="3022777" y="3628319"/>
            <a:ext cx="1587312" cy="2166705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F6F9CF20-AB48-4E07-96B7-234C77526BC3}"/>
              </a:ext>
            </a:extLst>
          </p:cNvPr>
          <p:cNvSpPr txBox="1"/>
          <p:nvPr/>
        </p:nvSpPr>
        <p:spPr>
          <a:xfrm>
            <a:off x="2966612" y="3291721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/>
                <a:cs typeface="Arial"/>
              </a:rPr>
              <a:t>400x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CD8B825-0F25-4D7D-B836-A671B204122D}"/>
              </a:ext>
            </a:extLst>
          </p:cNvPr>
          <p:cNvSpPr txBox="1"/>
          <p:nvPr/>
        </p:nvSpPr>
        <p:spPr>
          <a:xfrm>
            <a:off x="4871838" y="3279021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/>
                <a:cs typeface="Arial"/>
              </a:rPr>
              <a:t>400x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F9B7C73-E5FB-4806-B519-E89CD5FB3DE4}"/>
              </a:ext>
            </a:extLst>
          </p:cNvPr>
          <p:cNvSpPr txBox="1"/>
          <p:nvPr/>
        </p:nvSpPr>
        <p:spPr>
          <a:xfrm>
            <a:off x="6844409" y="3312898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/>
                <a:cs typeface="Arial"/>
              </a:rPr>
              <a:t>400x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7F0EF12-E608-41B9-B115-D1C229D2CDA9}"/>
              </a:ext>
            </a:extLst>
          </p:cNvPr>
          <p:cNvSpPr txBox="1"/>
          <p:nvPr/>
        </p:nvSpPr>
        <p:spPr>
          <a:xfrm>
            <a:off x="8892137" y="3291721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/>
                <a:cs typeface="Arial"/>
              </a:rPr>
              <a:t>400x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D93D9A7-0AB0-465F-9A86-A37DBE62F020}"/>
              </a:ext>
            </a:extLst>
          </p:cNvPr>
          <p:cNvSpPr txBox="1"/>
          <p:nvPr/>
        </p:nvSpPr>
        <p:spPr>
          <a:xfrm>
            <a:off x="2977970" y="5552646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/>
                <a:cs typeface="Arial"/>
              </a:rPr>
              <a:t>400x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2D8F679-2CFC-489A-A17F-E75453F51554}"/>
              </a:ext>
            </a:extLst>
          </p:cNvPr>
          <p:cNvSpPr txBox="1"/>
          <p:nvPr/>
        </p:nvSpPr>
        <p:spPr>
          <a:xfrm>
            <a:off x="4916596" y="5587237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/>
                <a:cs typeface="Arial"/>
              </a:rPr>
              <a:t>400x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D7AAD70-1F22-49B1-9FEB-9C06221D5BC8}"/>
              </a:ext>
            </a:extLst>
          </p:cNvPr>
          <p:cNvSpPr txBox="1"/>
          <p:nvPr/>
        </p:nvSpPr>
        <p:spPr>
          <a:xfrm>
            <a:off x="6829742" y="5585976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/>
                <a:cs typeface="Arial"/>
              </a:rPr>
              <a:t>400x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6C99AC8-2178-4471-8E80-5983D080B447}"/>
              </a:ext>
            </a:extLst>
          </p:cNvPr>
          <p:cNvSpPr txBox="1"/>
          <p:nvPr/>
        </p:nvSpPr>
        <p:spPr>
          <a:xfrm>
            <a:off x="8894053" y="5597383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/>
                <a:cs typeface="Arial"/>
              </a:rPr>
              <a:t>400x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E81659E-4301-4DBC-AFFD-18DA61CF7A01}"/>
              </a:ext>
            </a:extLst>
          </p:cNvPr>
          <p:cNvSpPr txBox="1"/>
          <p:nvPr/>
        </p:nvSpPr>
        <p:spPr>
          <a:xfrm>
            <a:off x="3863786" y="1539537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+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22F0476-C0C5-4B2D-8ACA-EB45D34C8D29}"/>
              </a:ext>
            </a:extLst>
          </p:cNvPr>
          <p:cNvSpPr txBox="1"/>
          <p:nvPr/>
        </p:nvSpPr>
        <p:spPr>
          <a:xfrm>
            <a:off x="3442725" y="2912605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+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E401FF3-DECC-420D-AFA6-CFAFD08CBA93}"/>
              </a:ext>
            </a:extLst>
          </p:cNvPr>
          <p:cNvSpPr txBox="1"/>
          <p:nvPr/>
        </p:nvSpPr>
        <p:spPr>
          <a:xfrm>
            <a:off x="5399134" y="2988895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+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F6AF7F4-E365-42FF-9B96-E96EE0544ECE}"/>
              </a:ext>
            </a:extLst>
          </p:cNvPr>
          <p:cNvSpPr txBox="1"/>
          <p:nvPr/>
        </p:nvSpPr>
        <p:spPr>
          <a:xfrm>
            <a:off x="5429717" y="1371576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+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7085482-E4F7-4C4A-87B9-33E606B4D1A8}"/>
              </a:ext>
            </a:extLst>
          </p:cNvPr>
          <p:cNvSpPr txBox="1"/>
          <p:nvPr/>
        </p:nvSpPr>
        <p:spPr>
          <a:xfrm>
            <a:off x="7144119" y="2693129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+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4E6D5E5-228B-4F1E-825D-8F6D6977D8EE}"/>
              </a:ext>
            </a:extLst>
          </p:cNvPr>
          <p:cNvSpPr txBox="1"/>
          <p:nvPr/>
        </p:nvSpPr>
        <p:spPr>
          <a:xfrm>
            <a:off x="9495633" y="1872912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+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C711FA8-95CD-4463-916F-45C4CC9F88D8}"/>
              </a:ext>
            </a:extLst>
          </p:cNvPr>
          <p:cNvSpPr txBox="1"/>
          <p:nvPr/>
        </p:nvSpPr>
        <p:spPr>
          <a:xfrm>
            <a:off x="3890139" y="5267670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+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73444A9-972F-4F32-B1EB-80DE84D6833E}"/>
              </a:ext>
            </a:extLst>
          </p:cNvPr>
          <p:cNvSpPr txBox="1"/>
          <p:nvPr/>
        </p:nvSpPr>
        <p:spPr>
          <a:xfrm>
            <a:off x="5336484" y="4364820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+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10B4D00-25AF-40D9-94A4-83133CCB0DB7}"/>
              </a:ext>
            </a:extLst>
          </p:cNvPr>
          <p:cNvSpPr txBox="1"/>
          <p:nvPr/>
        </p:nvSpPr>
        <p:spPr>
          <a:xfrm>
            <a:off x="7163359" y="4277975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+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46900B0-9190-4A74-82AC-C18C6A00B71F}"/>
              </a:ext>
            </a:extLst>
          </p:cNvPr>
          <p:cNvSpPr txBox="1"/>
          <p:nvPr/>
        </p:nvSpPr>
        <p:spPr>
          <a:xfrm>
            <a:off x="9645674" y="4668146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+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7458675-36F9-40F4-90BD-2A846754D248}"/>
              </a:ext>
            </a:extLst>
          </p:cNvPr>
          <p:cNvSpPr txBox="1"/>
          <p:nvPr/>
        </p:nvSpPr>
        <p:spPr>
          <a:xfrm>
            <a:off x="9123432" y="2319566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31500121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0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 Zoller</dc:creator>
  <cp:lastModifiedBy>Stephen Zoller</cp:lastModifiedBy>
  <cp:revision>1</cp:revision>
  <dcterms:created xsi:type="dcterms:W3CDTF">2020-08-22T04:25:19Z</dcterms:created>
  <dcterms:modified xsi:type="dcterms:W3CDTF">2020-08-22T04:25:29Z</dcterms:modified>
</cp:coreProperties>
</file>